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28" d="100"/>
          <a:sy n="128" d="100"/>
        </p:scale>
        <p:origin x="918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74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204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344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87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052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09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996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2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051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03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724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86AA95-C33A-43C8-A93C-2F1787262DE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2ABDF-F371-4885-9FBD-D6149B3D9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48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0668" y="1106617"/>
            <a:ext cx="180087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Supplemental Figure 1 </a:t>
            </a:r>
            <a:endParaRPr lang="en-US" sz="1350" dirty="0"/>
          </a:p>
        </p:txBody>
      </p:sp>
      <p:pic>
        <p:nvPicPr>
          <p:cNvPr id="5" name="Picture 4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55"/>
          <a:stretch/>
        </p:blipFill>
        <p:spPr bwMode="auto">
          <a:xfrm>
            <a:off x="364425" y="1976020"/>
            <a:ext cx="778669" cy="1707356"/>
          </a:xfrm>
          <a:prstGeom prst="rect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1332" y="1450317"/>
            <a:ext cx="1801178" cy="2253139"/>
          </a:xfrm>
          <a:prstGeom prst="rect">
            <a:avLst/>
          </a:prstGeom>
          <a:noFill/>
        </p:spPr>
      </p:pic>
      <p:sp>
        <p:nvSpPr>
          <p:cNvPr id="7" name="Rectangle 6"/>
          <p:cNvSpPr/>
          <p:nvPr/>
        </p:nvSpPr>
        <p:spPr>
          <a:xfrm>
            <a:off x="290668" y="3901269"/>
            <a:ext cx="4572000" cy="7294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15000"/>
              </a:lnSpc>
              <a:spcAft>
                <a:spcPts val="750"/>
              </a:spcAft>
            </a:pP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1: A) PCR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amplification of </a:t>
            </a:r>
            <a:r>
              <a:rPr lang="en-US" sz="9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wp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transcripts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rom the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IL fruit harboring either the 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9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abrochaites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allele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WP</a:t>
            </a:r>
            <a:r>
              <a:rPr lang="en-US" sz="9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H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left lane)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or the cultivated tomato allele (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WP</a:t>
            </a:r>
            <a:r>
              <a:rPr lang="en-US" sz="9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E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, middle lane),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=DNA marker).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) PCR amplification of </a:t>
            </a:r>
            <a:r>
              <a:rPr lang="en-US" sz="9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wp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transcripts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rom three green-fruited wild species and a cultivated variety of </a:t>
            </a:r>
            <a:r>
              <a:rPr lang="en-US" sz="900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. </a:t>
            </a:r>
            <a:r>
              <a:rPr lang="en-US" sz="9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lycopersicon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en-US" sz="900" dirty="0"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2991" y="2374556"/>
            <a:ext cx="28405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A</a:t>
            </a:r>
            <a:endParaRPr lang="en-US" sz="1350" dirty="0"/>
          </a:p>
        </p:txBody>
      </p:sp>
      <p:sp>
        <p:nvSpPr>
          <p:cNvPr id="9" name="TextBox 8"/>
          <p:cNvSpPr txBox="1"/>
          <p:nvPr/>
        </p:nvSpPr>
        <p:spPr>
          <a:xfrm>
            <a:off x="1334526" y="2374556"/>
            <a:ext cx="2792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B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47901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754" y="1362712"/>
            <a:ext cx="3914775" cy="32923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sp>
        <p:nvSpPr>
          <p:cNvPr id="5" name="Rectangle 4"/>
          <p:cNvSpPr/>
          <p:nvPr/>
        </p:nvSpPr>
        <p:spPr>
          <a:xfrm>
            <a:off x="55605" y="4786512"/>
            <a:ext cx="4572000" cy="104797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15000"/>
              </a:lnSpc>
              <a:spcAft>
                <a:spcPts val="750"/>
              </a:spcAft>
            </a:pP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2: Fragments of </a:t>
            </a:r>
            <a:r>
              <a:rPr lang="en-US" sz="9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wp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ntrons, with the YURAY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equences marked in red rectangles. (A) the TTAAT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equence in intron 1, (B) the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equence CTAAT in the native splicing variant of intron 2, (C) the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equence TTGAT in the alternative splicing variant of intron 2 and (D) the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equence TTAAC in intron 3. Poly-U tracts are found between the </a:t>
            </a:r>
            <a:r>
              <a:rPr lang="en-US" sz="900" dirty="0" err="1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ranchpoint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and the 3' junction of each intron. </a:t>
            </a:r>
            <a:endParaRPr lang="en-US" sz="900" dirty="0"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04754" y="1085713"/>
            <a:ext cx="1762406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50" dirty="0">
                <a:ea typeface="Times New Roman" panose="02020603050405020304" pitchFamily="18" charset="0"/>
                <a:cs typeface="Arial" panose="020B0604020202020204" pitchFamily="34" charset="0"/>
              </a:rPr>
              <a:t>Supplemental Figure 2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3588885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12777" y="730437"/>
            <a:ext cx="5944872" cy="2974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4822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429" y="657259"/>
            <a:ext cx="5944872" cy="2710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5895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61</Words>
  <Application>Microsoft Office PowerPoint</Application>
  <PresentationFormat>On-screen Show (4:3)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 Schaffer</dc:creator>
  <cp:lastModifiedBy>Ari Schaffer</cp:lastModifiedBy>
  <cp:revision>1</cp:revision>
  <dcterms:created xsi:type="dcterms:W3CDTF">2019-05-29T14:00:53Z</dcterms:created>
  <dcterms:modified xsi:type="dcterms:W3CDTF">2019-05-29T14:05:37Z</dcterms:modified>
</cp:coreProperties>
</file>